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4" r:id="rId2"/>
    <p:sldId id="287" r:id="rId3"/>
    <p:sldId id="27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00" d="100"/>
          <a:sy n="200" d="100"/>
        </p:scale>
        <p:origin x="-2942" y="11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064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214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942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48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765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818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140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681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354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483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970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88E1C6-BB64-405D-843A-6B0EFF20D0D0}" type="datetimeFigureOut">
              <a:rPr lang="en-US" smtClean="0"/>
              <a:t>2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65D55-3E27-426A-AC22-691AEADFC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687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018922" y="107354"/>
            <a:ext cx="17618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S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4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689949"/>
              </p:ext>
            </p:extLst>
          </p:nvPr>
        </p:nvGraphicFramePr>
        <p:xfrm>
          <a:off x="2018922" y="415131"/>
          <a:ext cx="5069941" cy="582590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324553">
                  <a:extLst>
                    <a:ext uri="{9D8B030D-6E8A-4147-A177-3AD203B41FA5}">
                      <a16:colId xmlns:a16="http://schemas.microsoft.com/office/drawing/2014/main" val="2041549779"/>
                    </a:ext>
                  </a:extLst>
                </a:gridCol>
                <a:gridCol w="1745388">
                  <a:extLst>
                    <a:ext uri="{9D8B030D-6E8A-4147-A177-3AD203B41FA5}">
                      <a16:colId xmlns:a16="http://schemas.microsoft.com/office/drawing/2014/main" val="3108592580"/>
                    </a:ext>
                  </a:extLst>
                </a:gridCol>
              </a:tblGrid>
              <a:tr h="10749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Codes identifica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Cod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548476726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sng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Patient description (inclusion)</a:t>
                      </a:r>
                      <a:endParaRPr lang="en-US" sz="800" b="0" i="0" u="sng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074268198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Femal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UMLS:HL7V3.0:Gender: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744296967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Menopa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95; Z78.0; E89.41; E28.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463480110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Burn injur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T20-T25; T26-T28; T30-T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9174643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sng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Pre-existing diseases (exclusion)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003058542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Breast canc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3773616235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Abnormal uterine and vaginal bleed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9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3127500697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Chronic kidney disease (CKD) &amp; Kidney failur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18; N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126471798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hronic ischemic heart disease &amp; Heart failur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I25; I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70624125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Hepatic failure&amp; Liver dise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K72; K7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39997569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Female genital organ cancer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56; C57; Z85.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021282763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sng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Medications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3737163805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adio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408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746229257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thinyl estradio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41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377838366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41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926647197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s, conjugated (USP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40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771812512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Synthetic conjugated estrogens, 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25316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542583475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ic substanc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2592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245403402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s, esterified (USP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2145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074392862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Synthetic conjugated estrogens, 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RXNORM:61836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594484334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s, combinations with other drug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529372682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atural and semisynthetic estrogens, pl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666881133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Progestogens and estrogens, fixed combinatio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260480856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L02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119360632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Progestogens and estrogens, sequential preparatio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A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3436001949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Synthetic estrogens, pla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C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570739739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Other estroge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C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978170852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Selective estrogen receptor modulator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X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81034265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ATC:G03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007280821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STROGE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VA:HS3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062223521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ESTRADIOL </a:t>
                      </a:r>
                      <a:r>
                        <a:rPr lang="en-US" sz="800" u="none" strike="noStrike" err="1">
                          <a:effectLst/>
                          <a:latin typeface="+mn-lt"/>
                          <a:cs typeface="Arial" panose="020B0604020202020204" pitchFamily="34" charset="0"/>
                        </a:rPr>
                        <a:t>CREAM</a:t>
                      </a:r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, Vaginal </a:t>
                      </a:r>
                      <a:r>
                        <a:rPr lang="en-US" sz="8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(VAG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LM:VA:GU5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383764150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sng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Progress outcome</a:t>
                      </a:r>
                      <a:endParaRPr lang="en-US" sz="800" b="0" i="0" u="sng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92320294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Deat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R9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4187643693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 Sep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A41; R65.2; A40.8; A40.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567698685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Hyperten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I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066301213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erebral infarc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I6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3715685895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ardiac infarct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I21; I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918402057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cute kidney failure (AKF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991681016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K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564845221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 Osteoporo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M80; M8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518901061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Breast canc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583415171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ndometro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N85.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320536650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Endometrium malignanc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C54.1; C54.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1930371990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Hypertrophic sc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+mn-lt"/>
                          <a:cs typeface="Arial" panose="020B0604020202020204" pitchFamily="34" charset="0"/>
                        </a:rPr>
                        <a:t>L9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3466735748"/>
                  </a:ext>
                </a:extLst>
              </a:tr>
              <a:tr h="107490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Skin wound infec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L0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4730" marR="4730" marT="4730" marB="0" anchor="b"/>
                </a:tc>
                <a:extLst>
                  <a:ext uri="{0D108BD9-81ED-4DB2-BD59-A6C34878D82A}">
                    <a16:rowId xmlns:a16="http://schemas.microsoft.com/office/drawing/2014/main" val="2961466811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127563" y="6241031"/>
            <a:ext cx="4572000" cy="26161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100" dirty="0"/>
              <a:t>UMLS:ICD10CM      ; or</a:t>
            </a:r>
          </a:p>
        </p:txBody>
      </p:sp>
    </p:spTree>
    <p:extLst>
      <p:ext uri="{BB962C8B-B14F-4D97-AF65-F5344CB8AC3E}">
        <p14:creationId xmlns:p14="http://schemas.microsoft.com/office/powerpoint/2010/main" val="2607231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E6CF15A-E922-7E46-5A6A-164E0F2054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5725338"/>
              </p:ext>
            </p:extLst>
          </p:nvPr>
        </p:nvGraphicFramePr>
        <p:xfrm>
          <a:off x="2460412" y="993067"/>
          <a:ext cx="3956475" cy="4511505"/>
        </p:xfrm>
        <a:graphic>
          <a:graphicData uri="http://schemas.openxmlformats.org/drawingml/2006/table">
            <a:tbl>
              <a:tblPr/>
              <a:tblGrid>
                <a:gridCol w="2159403">
                  <a:extLst>
                    <a:ext uri="{9D8B030D-6E8A-4147-A177-3AD203B41FA5}">
                      <a16:colId xmlns:a16="http://schemas.microsoft.com/office/drawing/2014/main" val="4183777652"/>
                    </a:ext>
                  </a:extLst>
                </a:gridCol>
                <a:gridCol w="571541">
                  <a:extLst>
                    <a:ext uri="{9D8B030D-6E8A-4147-A177-3AD203B41FA5}">
                      <a16:colId xmlns:a16="http://schemas.microsoft.com/office/drawing/2014/main" val="1737163137"/>
                    </a:ext>
                  </a:extLst>
                </a:gridCol>
                <a:gridCol w="1225531">
                  <a:extLst>
                    <a:ext uri="{9D8B030D-6E8A-4147-A177-3AD203B41FA5}">
                      <a16:colId xmlns:a16="http://schemas.microsoft.com/office/drawing/2014/main" val="4080447091"/>
                    </a:ext>
                  </a:extLst>
                </a:gridCol>
              </a:tblGrid>
              <a:tr h="591620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ication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atients (n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% patien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0220851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stradiol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09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.98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7605648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strogens, conjugated (USP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48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1.46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8832959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thinyl estradiol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3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.43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7055471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strogen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79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9702646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gestimat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4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62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0002215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loxifen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09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5875055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strogens, esterified (USP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4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65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82460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stropipat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4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0206383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spemifen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9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975255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ynthetic conjugated estrogens, A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9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6228421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striol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4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1775642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relgestromin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4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1573386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stron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5%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8008268"/>
                  </a:ext>
                </a:extLst>
              </a:tr>
              <a:tr h="268551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ynthetic conjugated estrogens, B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5%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413" marR="8413" marT="841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4538433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EB5433CD-8028-8AED-D174-8B55EF64081F}"/>
              </a:ext>
            </a:extLst>
          </p:cNvPr>
          <p:cNvSpPr/>
          <p:nvPr/>
        </p:nvSpPr>
        <p:spPr>
          <a:xfrm>
            <a:off x="1247397" y="612179"/>
            <a:ext cx="173554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S2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367455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1143000"/>
            <a:ext cx="6096000" cy="4572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311309" y="613138"/>
            <a:ext cx="19329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870751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35</TotalTime>
  <Words>402</Words>
  <Application>Microsoft Office PowerPoint</Application>
  <PresentationFormat>On-screen Show (4:3)</PresentationFormat>
  <Paragraphs>13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Shriners Hospitals for Childr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g, Juquan</dc:creator>
  <cp:lastModifiedBy>MDPI</cp:lastModifiedBy>
  <cp:revision>66</cp:revision>
  <dcterms:created xsi:type="dcterms:W3CDTF">2023-09-17T00:35:57Z</dcterms:created>
  <dcterms:modified xsi:type="dcterms:W3CDTF">2025-02-09T08:00:30Z</dcterms:modified>
</cp:coreProperties>
</file>